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3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8" d="100"/>
          <a:sy n="68" d="100"/>
        </p:scale>
        <p:origin x="61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00892D-E1A8-4EFC-AA07-862411416856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FBA491-E2EE-46FD-98AC-CD1376F7EA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6336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7388" y="1143000"/>
            <a:ext cx="5484812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50E4635-6599-49F1-BB7B-439F7A78D51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18713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894E7B-3D99-4CF4-B36C-720B135600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344D0D1-2526-4FB9-BD6D-BA5E2D0BC45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1BE54E-5B09-4E05-AB5C-8104C14105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4F4A1-CDC5-4453-9DE9-70C41257D506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51AFB5-E514-4D8D-9855-EFAB8B2F05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83A71B-2254-4691-916E-8741AABFD0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65ADB-D08E-447B-AFA4-66BFBC1B5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51610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BA9CE7-6CE0-4F18-B948-96828104E8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E92ED2E-5248-429F-A8E6-26FF5146CD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A253F5-23D1-4C8D-AE7C-DC05745F7B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4F4A1-CDC5-4453-9DE9-70C41257D506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41EC5B-47A3-4814-AEE6-BC270269D7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7B9C3D-3D55-4CDA-BBEF-E932C33D1B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65ADB-D08E-447B-AFA4-66BFBC1B5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02514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915F131-320F-4606-83D5-A4CA287D49B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017F1B0-81A7-4BE9-B929-E5F558AAF3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149073-501F-4E0D-8C20-A59B494F31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4F4A1-CDC5-4453-9DE9-70C41257D506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29262F-C06A-4BD4-87E9-87E859A977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401A2E-0701-4989-9BC4-422B56DDCD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65ADB-D08E-447B-AFA4-66BFBC1B5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0216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59D1D4-C670-40B4-BB30-E01F92B5C8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A040E4-E1E3-4B74-812A-07BE3BCDB74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5893F6-1B87-4F13-BEF6-784C7C9C47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4F4A1-CDC5-4453-9DE9-70C41257D506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7A3D7E-BCDD-4DBB-81B6-AD92F5BE9A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AF1330-0834-4004-96FE-BF05A8E54B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65ADB-D08E-447B-AFA4-66BFBC1B5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85273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9BDF77-E6E0-4117-8D1B-4AAFF4E338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6869AC-2254-4614-9C81-262283880A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F79F83-3416-4261-B17E-90FE3913CE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4F4A1-CDC5-4453-9DE9-70C41257D506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F54170-5B5F-4183-B741-8691832CEC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2E070B-873E-4780-902C-4AFBF0829A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65ADB-D08E-447B-AFA4-66BFBC1B5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9317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3A704D-F2BF-43F5-9ED4-0BEAFB2CCB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FD7197-F513-46F9-A345-C9ACD4B55AB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AC22BD7-5F1D-4B1E-BAD9-E4913EB2F2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BE06E10-151F-479D-B7B0-E4F6A297FB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4F4A1-CDC5-4453-9DE9-70C41257D506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606C14-C4E4-4144-ACEC-E964EF9EAB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D1F05E-E303-412A-A269-58ED810301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65ADB-D08E-447B-AFA4-66BFBC1B5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1539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5D58A6-BCF6-4AA3-94F0-7775640FB4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89FA0A-65E1-4DB9-AC03-D3C044AB6C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4B99229-EDB8-40AC-9B45-3B7EC9EC25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90EBB26-84AA-43DA-A669-4CC7F38808A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579A98E-4464-485A-B7A6-91D5AEB911E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B4193A5-6BD5-4C07-B807-D89BDA4A2D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4F4A1-CDC5-4453-9DE9-70C41257D506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059AACA-EE38-4ABA-906D-38451D03BF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C51CB82-533C-4E03-B4D4-F1B55EE875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65ADB-D08E-447B-AFA4-66BFBC1B5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996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4491BD-3024-4B09-BFC6-212CFE78BB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4B90957-8FF5-4838-B68A-B64EB20118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4F4A1-CDC5-4453-9DE9-70C41257D506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F2304D3-1E52-46C9-B3A9-1F646740A2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563C139-049C-44AD-B892-1C8E3088FA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65ADB-D08E-447B-AFA4-66BFBC1B5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9079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580E94D-184F-470F-A170-882EE592EA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4F4A1-CDC5-4453-9DE9-70C41257D506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20BF9B0-3630-4916-B538-9F6D605257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BC94C5D-5534-4A10-885E-85164F9C35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65ADB-D08E-447B-AFA4-66BFBC1B5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8871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880E1A-948D-4650-A426-D66F26921D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7FBFEB-EE0B-442A-B018-B7695DA20D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E628F40-5526-4C64-B4CA-65DF2D7994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945DA4-BB08-4B1E-83FF-182C7C37A6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4F4A1-CDC5-4453-9DE9-70C41257D506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F23487-FB58-47A3-919C-B86F44FBF4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C1C96A-4196-40C2-A9DF-CB8825E001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65ADB-D08E-447B-AFA4-66BFBC1B5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5070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5D8D86-4C30-4082-BE01-781A6978DE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80D7B8B-8B66-4074-8527-936E62B85E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2481B32-CC69-4F97-B12D-F77B3D9A38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9EE55E-A349-4685-9586-8F18DC1B64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4F4A1-CDC5-4453-9DE9-70C41257D506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FD83A6C-8A6F-40CF-A492-F97C8CB322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7E869F-A70C-45B2-9C33-2B6D5C970D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65ADB-D08E-447B-AFA4-66BFBC1B5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99166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1520F54-13A2-4377-9467-5CC4F69581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C0550E-FEE8-4844-8D55-3029859145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05FE34-9708-46AD-B125-D9E0EBD7D59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84F4A1-CDC5-4453-9DE9-70C41257D506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1D8D48-16D7-4D1F-AE2C-A58CEC92E2B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9B07EE-DB54-462A-A22B-760635AC098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C65ADB-D08E-447B-AFA4-66BFBC1B5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26191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png"/><Relationship Id="rId3" Type="http://schemas.microsoft.com/office/2007/relationships/media" Target="../media/media2.mp4"/><Relationship Id="rId7" Type="http://schemas.openxmlformats.org/officeDocument/2006/relationships/image" Target="../media/image1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notesSlide" Target="../notesSlides/notesSlide1.xml"/><Relationship Id="rId5" Type="http://schemas.openxmlformats.org/officeDocument/2006/relationships/slideLayout" Target="../slideLayouts/slideLayout7.xml"/><Relationship Id="rId4" Type="http://schemas.openxmlformats.org/officeDocument/2006/relationships/video" Target="../media/media2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6BBD901-01A4-4EFA-9197-F7073D5C68F9}"/>
              </a:ext>
            </a:extLst>
          </p:cNvPr>
          <p:cNvSpPr txBox="1"/>
          <p:nvPr/>
        </p:nvSpPr>
        <p:spPr>
          <a:xfrm>
            <a:off x="743096" y="5196088"/>
            <a:ext cx="10416316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7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Video S1. Time-lapse video of organoid formation with or without centrifugation over 24 hours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8FA6E93-CBE3-4BF8-BA9A-85D869B93A18}"/>
              </a:ext>
            </a:extLst>
          </p:cNvPr>
          <p:cNvSpPr txBox="1"/>
          <p:nvPr/>
        </p:nvSpPr>
        <p:spPr>
          <a:xfrm>
            <a:off x="2009399" y="768679"/>
            <a:ext cx="804029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Without centrifugation			          With centrifugation</a:t>
            </a:r>
          </a:p>
        </p:txBody>
      </p:sp>
      <p:pic>
        <p:nvPicPr>
          <p:cNvPr id="9" name="VID707_G7_1">
            <a:hlinkClick r:id="" action="ppaction://media"/>
            <a:extLst>
              <a:ext uri="{FF2B5EF4-FFF2-40B4-BE49-F238E27FC236}">
                <a16:creationId xmlns:a16="http://schemas.microsoft.com/office/drawing/2014/main" id="{DC6978EF-4847-4769-84CE-84379AC8B33D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743096" y="1261419"/>
            <a:ext cx="5147388" cy="3795957"/>
          </a:xfrm>
          <a:prstGeom prst="rect">
            <a:avLst/>
          </a:prstGeom>
        </p:spPr>
      </p:pic>
      <p:pic>
        <p:nvPicPr>
          <p:cNvPr id="10" name="VID707_I7_1">
            <a:hlinkClick r:id="" action="ppaction://media"/>
            <a:extLst>
              <a:ext uri="{FF2B5EF4-FFF2-40B4-BE49-F238E27FC236}">
                <a16:creationId xmlns:a16="http://schemas.microsoft.com/office/drawing/2014/main" id="{D7F16DDB-F328-416A-BCB3-25A3C42DEA72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6012025" y="1261420"/>
            <a:ext cx="5147387" cy="37959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455330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6000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26000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1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  <p:seq concurrent="1" nextAc="seek">
              <p:cTn id="12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" fill="hold">
                      <p:stCondLst>
                        <p:cond delay="0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  <p:video>
              <p:cMediaNode vol="80000">
                <p:cTn id="17" fill="hold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  <p:seq concurrent="1" nextAc="seek">
              <p:cTn id="18" restart="whenNotActive" fill="hold" evtFilter="cancelBubble" nodeType="interactiveSeq">
                <p:stCondLst>
                  <p:cond evt="onClick" delay="0">
                    <p:tgtEl>
                      <p:spTgt spid="1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9" fill="hold">
                      <p:stCondLst>
                        <p:cond delay="0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2" dur="1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0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6</Words>
  <Application>Microsoft Office PowerPoint</Application>
  <PresentationFormat>Widescreen</PresentationFormat>
  <Paragraphs>3</Paragraphs>
  <Slides>1</Slides>
  <Notes>1</Notes>
  <HiddenSlides>0</HiddenSlides>
  <MMClips>2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g, Jonathan J</dc:creator>
  <cp:lastModifiedBy>Chang, Jonathan J</cp:lastModifiedBy>
  <cp:revision>1</cp:revision>
  <dcterms:created xsi:type="dcterms:W3CDTF">2021-11-08T21:55:00Z</dcterms:created>
  <dcterms:modified xsi:type="dcterms:W3CDTF">2021-11-08T21:56:28Z</dcterms:modified>
</cp:coreProperties>
</file>